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55" d="100"/>
          <a:sy n="55" d="100"/>
        </p:scale>
        <p:origin x="-912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BB051-4DD1-4049-A187-A955CC7E073E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CE2F5-267F-4506-BEB6-846CA25F9F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99004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BB051-4DD1-4049-A187-A955CC7E073E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CE2F5-267F-4506-BEB6-846CA25F9F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66332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BB051-4DD1-4049-A187-A955CC7E073E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CE2F5-267F-4506-BEB6-846CA25F9F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56192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BB051-4DD1-4049-A187-A955CC7E073E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CE2F5-267F-4506-BEB6-846CA25F9F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21755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BB051-4DD1-4049-A187-A955CC7E073E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CE2F5-267F-4506-BEB6-846CA25F9F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00552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BB051-4DD1-4049-A187-A955CC7E073E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CE2F5-267F-4506-BEB6-846CA25F9F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05035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BB051-4DD1-4049-A187-A955CC7E073E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CE2F5-267F-4506-BEB6-846CA25F9F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6400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BB051-4DD1-4049-A187-A955CC7E073E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CE2F5-267F-4506-BEB6-846CA25F9F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03434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BB051-4DD1-4049-A187-A955CC7E073E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CE2F5-267F-4506-BEB6-846CA25F9F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030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BB051-4DD1-4049-A187-A955CC7E073E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CE2F5-267F-4506-BEB6-846CA25F9F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17697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3BB051-4DD1-4049-A187-A955CC7E073E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2CE2F5-267F-4506-BEB6-846CA25F9F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1729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3BB051-4DD1-4049-A187-A955CC7E073E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2CE2F5-267F-4506-BEB6-846CA25F9F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17957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98452" y="177195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Figure S1</a:t>
            </a:r>
            <a:endParaRPr lang="en-US" dirty="0">
              <a:latin typeface="Helvetica"/>
              <a:cs typeface="Helvetica"/>
            </a:endParaRPr>
          </a:p>
        </p:txBody>
      </p:sp>
      <p:graphicFrame>
        <p:nvGraphicFramePr>
          <p:cNvPr id="10" name="Table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11593568"/>
              </p:ext>
            </p:extLst>
          </p:nvPr>
        </p:nvGraphicFramePr>
        <p:xfrm>
          <a:off x="665677" y="905300"/>
          <a:ext cx="8306529" cy="2159337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359829"/>
                <a:gridCol w="1568609"/>
                <a:gridCol w="1590112"/>
                <a:gridCol w="1198528"/>
                <a:gridCol w="1767799"/>
                <a:gridCol w="821652"/>
              </a:tblGrid>
              <a:tr h="513417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Helvetica"/>
                          <a:ea typeface="ＭＳ 明朝"/>
                          <a:cs typeface="Helvetica"/>
                        </a:rPr>
                        <a:t>KEGG pathway</a:t>
                      </a: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Helvetica"/>
                          <a:ea typeface="ＭＳ 明朝"/>
                          <a:cs typeface="Helvetica"/>
                        </a:rPr>
                        <a:t>Regulated (Up/down) genes</a:t>
                      </a: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Helvetica"/>
                          <a:ea typeface="ＭＳ 明朝"/>
                          <a:cs typeface="Helvetica"/>
                        </a:rPr>
                        <a:t>Number of genes in pathway</a:t>
                      </a: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Helvetica"/>
                          <a:ea typeface="ＭＳ 明朝"/>
                          <a:cs typeface="Helvetica"/>
                        </a:rPr>
                        <a:t>% genes changed</a:t>
                      </a: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Helvetica"/>
                          <a:ea typeface="ＭＳ 明朝"/>
                          <a:cs typeface="Helvetica"/>
                        </a:rPr>
                        <a:t> </a:t>
                      </a: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Helvetica"/>
                          <a:ea typeface="ＭＳ 明朝"/>
                          <a:cs typeface="Helvetica"/>
                        </a:rPr>
                        <a:t>Top regulated genes</a:t>
                      </a: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Helvetica"/>
                          <a:ea typeface="ＭＳ 明朝"/>
                          <a:cs typeface="Helvetica"/>
                        </a:rPr>
                        <a:t>p-Value</a:t>
                      </a:r>
                    </a:p>
                  </a:txBody>
                  <a:tcPr marT="0" marB="0"/>
                </a:tc>
              </a:tr>
              <a:tr h="54864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ＭＳ 明朝"/>
                          <a:cs typeface="Helvetica"/>
                        </a:rPr>
                        <a:t>SNARE interactions in vesicular transport</a:t>
                      </a:r>
                      <a:endParaRPr lang="en-US" sz="900" dirty="0">
                        <a:effectLst/>
                        <a:latin typeface="Helvetica"/>
                        <a:ea typeface="ＭＳ 明朝"/>
                        <a:cs typeface="Helvetica"/>
                      </a:endParaRP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Helvetica"/>
                          <a:ea typeface="ＭＳ 明朝"/>
                          <a:cs typeface="Helvetica"/>
                        </a:rPr>
                        <a:t>15 (14/1) </a:t>
                      </a: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Helvetica"/>
                          <a:ea typeface="ＭＳ 明朝"/>
                          <a:cs typeface="Helvetica"/>
                        </a:rPr>
                        <a:t>36</a:t>
                      </a: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Helvetica"/>
                          <a:ea typeface="ＭＳ 明朝"/>
                          <a:cs typeface="Helvetica"/>
                        </a:rPr>
                        <a:t>41</a:t>
                      </a: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Helvetica"/>
                          <a:ea typeface="ＭＳ 明朝"/>
                          <a:cs typeface="Helvetica"/>
                        </a:rPr>
                        <a:t>STX1-4; SNAP23, STX6, STX7, VAMP8</a:t>
                      </a: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Helvetica"/>
                          <a:ea typeface="ＭＳ 明朝"/>
                          <a:cs typeface="Helvetica"/>
                        </a:rPr>
                        <a:t>1.1 E-04</a:t>
                      </a:r>
                    </a:p>
                  </a:txBody>
                  <a:tcPr marT="0" marB="0"/>
                </a:tc>
              </a:tr>
              <a:tr h="68580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ＭＳ 明朝"/>
                          <a:cs typeface="Helvetica"/>
                        </a:rPr>
                        <a:t>MAPK signaling pathway</a:t>
                      </a:r>
                      <a:endParaRPr lang="en-US" sz="900" dirty="0">
                        <a:effectLst/>
                        <a:latin typeface="Helvetica"/>
                        <a:ea typeface="ＭＳ 明朝"/>
                        <a:cs typeface="Helvetica"/>
                      </a:endParaRP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Helvetica"/>
                          <a:ea typeface="ＭＳ 明朝"/>
                          <a:cs typeface="Helvetica"/>
                        </a:rPr>
                        <a:t>62 (49/13) </a:t>
                      </a: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Helvetica"/>
                          <a:ea typeface="ＭＳ 明朝"/>
                          <a:cs typeface="Helvetica"/>
                        </a:rPr>
                        <a:t>268</a:t>
                      </a: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Helvetica"/>
                          <a:ea typeface="ＭＳ 明朝"/>
                          <a:cs typeface="Helvetica"/>
                        </a:rPr>
                        <a:t>23</a:t>
                      </a: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Helvetica"/>
                          <a:ea typeface="ＭＳ 明朝"/>
                          <a:cs typeface="Helvetica"/>
                        </a:rPr>
                        <a:t>Ras, PKC, IKK, NFkB, JNK, c-Jun, GADD45, PKA, PKA1/2, AKT, MKP</a:t>
                      </a: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Helvetica"/>
                          <a:ea typeface="ＭＳ 明朝"/>
                          <a:cs typeface="Helvetica"/>
                        </a:rPr>
                        <a:t>1.4 E-04</a:t>
                      </a:r>
                    </a:p>
                  </a:txBody>
                  <a:tcPr marT="0" marB="0"/>
                </a:tc>
              </a:tr>
              <a:tr h="41148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latin typeface="Helvetica"/>
                          <a:ea typeface="ＭＳ 明朝"/>
                          <a:cs typeface="Helvetica"/>
                        </a:rPr>
                        <a:t>Endocytosis</a:t>
                      </a:r>
                      <a:endParaRPr lang="en-US" sz="900" dirty="0">
                        <a:effectLst/>
                        <a:latin typeface="Helvetica"/>
                        <a:ea typeface="ＭＳ 明朝"/>
                        <a:cs typeface="Helvetica"/>
                      </a:endParaRP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Helvetica"/>
                          <a:ea typeface="ＭＳ 明朝"/>
                          <a:cs typeface="Helvetica"/>
                        </a:rPr>
                        <a:t>42 (34/8)</a:t>
                      </a: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Helvetica"/>
                          <a:ea typeface="ＭＳ 明朝"/>
                          <a:cs typeface="Helvetica"/>
                        </a:rPr>
                        <a:t>205</a:t>
                      </a: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Helvetica"/>
                          <a:ea typeface="ＭＳ 明朝"/>
                          <a:cs typeface="Helvetica"/>
                        </a:rPr>
                        <a:t>20</a:t>
                      </a: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Helvetica"/>
                          <a:ea typeface="ＭＳ 明朝"/>
                          <a:cs typeface="Helvetica"/>
                        </a:rPr>
                        <a:t>RTK, clathrin, Hrs, FIP, VPS37, LDLR, CHMP4</a:t>
                      </a: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Helvetica"/>
                          <a:ea typeface="ＭＳ 明朝"/>
                          <a:cs typeface="Helvetica"/>
                        </a:rPr>
                        <a:t>6.0 E-03</a:t>
                      </a:r>
                    </a:p>
                  </a:txBody>
                  <a:tcPr marT="0" marB="0"/>
                </a:tc>
              </a:tr>
            </a:tbl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8276521" y="6518879"/>
            <a:ext cx="407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358890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8</Words>
  <Application>Microsoft Office PowerPoint</Application>
  <PresentationFormat>On-screen Show (4:3)</PresentationFormat>
  <Paragraphs>2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rie</dc:creator>
  <cp:lastModifiedBy>Karie</cp:lastModifiedBy>
  <cp:revision>1</cp:revision>
  <dcterms:created xsi:type="dcterms:W3CDTF">2013-12-11T00:13:35Z</dcterms:created>
  <dcterms:modified xsi:type="dcterms:W3CDTF">2013-12-11T00:14:24Z</dcterms:modified>
</cp:coreProperties>
</file>